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21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s S2e2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D3289DB-07CD-B043-A4F4-75B11AB918F2}"/>
              </a:ext>
            </a:extLst>
          </p:cNvPr>
          <p:cNvSpPr/>
          <p:nvPr/>
        </p:nvSpPr>
        <p:spPr>
          <a:xfrm>
            <a:off x="1004993" y="426896"/>
            <a:ext cx="48480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Representation of cell track by color and arrow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ACB1B146-3BC1-184F-9D05-A15FD25D4920}"/>
              </a:ext>
            </a:extLst>
          </p:cNvPr>
          <p:cNvGrpSpPr/>
          <p:nvPr/>
        </p:nvGrpSpPr>
        <p:grpSpPr>
          <a:xfrm>
            <a:off x="2633782" y="7329833"/>
            <a:ext cx="1590437" cy="371420"/>
            <a:chOff x="2516690" y="7302123"/>
            <a:chExt cx="1590437" cy="371420"/>
          </a:xfrm>
        </p:grpSpPr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E469B61D-635D-BC48-9D20-186124643AB9}"/>
                </a:ext>
              </a:extLst>
            </p:cNvPr>
            <p:cNvSpPr/>
            <p:nvPr/>
          </p:nvSpPr>
          <p:spPr>
            <a:xfrm>
              <a:off x="3429000" y="7302123"/>
              <a:ext cx="67812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dirty="0">
                  <a:latin typeface="Times New Roman" panose="02020603050405020304" pitchFamily="18" charset="0"/>
                  <a:ea typeface="Arial Unicode MS" panose="020B0604020202020204" pitchFamily="34" charset="-128"/>
                  <a:cs typeface="Times New Roman" panose="02020603050405020304" pitchFamily="18" charset="0"/>
                </a:rPr>
                <a:t>Blue </a:t>
              </a:r>
              <a:endPara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7DDCAEB9-AC03-8049-981B-F2EABF7D545B}"/>
                </a:ext>
              </a:extLst>
            </p:cNvPr>
            <p:cNvCxnSpPr/>
            <p:nvPr/>
          </p:nvCxnSpPr>
          <p:spPr>
            <a:xfrm>
              <a:off x="3194486" y="7483926"/>
              <a:ext cx="234514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8271951A-3E41-0040-B559-DC979BB4A4F8}"/>
                </a:ext>
              </a:extLst>
            </p:cNvPr>
            <p:cNvSpPr/>
            <p:nvPr/>
          </p:nvSpPr>
          <p:spPr>
            <a:xfrm>
              <a:off x="2516690" y="7304211"/>
              <a:ext cx="67812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dirty="0">
                  <a:latin typeface="Times New Roman" panose="02020603050405020304" pitchFamily="18" charset="0"/>
                  <a:ea typeface="Arial Unicode MS" panose="020B0604020202020204" pitchFamily="34" charset="-128"/>
                  <a:cs typeface="Times New Roman" panose="02020603050405020304" pitchFamily="18" charset="0"/>
                </a:rPr>
                <a:t>Red </a:t>
              </a:r>
              <a:endPara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A9503F34-FF4E-C640-BB64-32FC0DE6F0F7}"/>
              </a:ext>
            </a:extLst>
          </p:cNvPr>
          <p:cNvSpPr/>
          <p:nvPr/>
        </p:nvSpPr>
        <p:spPr>
          <a:xfrm>
            <a:off x="1" y="-18901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e2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D445F2E2-2309-0D4D-B2D1-7D4AD10FC4B0}"/>
              </a:ext>
            </a:extLst>
          </p:cNvPr>
          <p:cNvGrpSpPr/>
          <p:nvPr/>
        </p:nvGrpSpPr>
        <p:grpSpPr>
          <a:xfrm>
            <a:off x="177800" y="769222"/>
            <a:ext cx="6502400" cy="6502400"/>
            <a:chOff x="177800" y="769222"/>
            <a:chExt cx="6502400" cy="6502400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47C48E59-C449-4B46-BEBB-046E7D43D83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7800" y="769222"/>
              <a:ext cx="6502400" cy="6502400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id="{59308815-297E-E247-8218-2E886F1F1B58}"/>
                </a:ext>
              </a:extLst>
            </p:cNvPr>
            <p:cNvCxnSpPr/>
            <p:nvPr/>
          </p:nvCxnSpPr>
          <p:spPr>
            <a:xfrm flipV="1">
              <a:off x="3870960" y="2831702"/>
              <a:ext cx="91440" cy="14859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E43F546E-0572-8F47-841A-F66536ECCA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94990" y="2385932"/>
              <a:ext cx="281060" cy="10795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矢印コネクタ 10">
              <a:extLst>
                <a:ext uri="{FF2B5EF4-FFF2-40B4-BE49-F238E27FC236}">
                  <a16:creationId xmlns:a16="http://schemas.microsoft.com/office/drawing/2014/main" id="{C47C6485-1010-9540-BE0A-888E00CC2C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31080" y="1700132"/>
              <a:ext cx="102870" cy="32004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5D37D639-50A3-EF47-94F3-EAAAB809934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82290" y="1642982"/>
              <a:ext cx="259080" cy="10784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8BB972B0-50D1-5040-B5A3-2653449C09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71112" y="1642981"/>
              <a:ext cx="143887" cy="13847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58F9836B-70A8-9842-8FD2-40BEB8BE58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62299" y="1362244"/>
              <a:ext cx="143887" cy="13847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5B5CA4B2-4828-4840-B7AB-C97BD0F31E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41370" y="2656478"/>
              <a:ext cx="183519" cy="3500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AEDB60DF-E76E-D540-B18F-E493C8701DE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98772" y="3448375"/>
              <a:ext cx="236730" cy="17427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17D9AED3-873A-D646-9EF3-F61EF2152D8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62365" y="3135335"/>
              <a:ext cx="236730" cy="17427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32F006F0-FC2A-3F40-84E6-0458E06717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41370" y="2980292"/>
              <a:ext cx="262270" cy="10494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B1D66296-E82E-AB4F-BD50-3791455D5F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99095" y="3102148"/>
              <a:ext cx="343921" cy="17279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9313D7BB-B6BC-E847-8861-C46865DB6D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94721" y="3257930"/>
              <a:ext cx="308919" cy="11612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矢印コネクタ 20">
              <a:extLst>
                <a:ext uri="{FF2B5EF4-FFF2-40B4-BE49-F238E27FC236}">
                  <a16:creationId xmlns:a16="http://schemas.microsoft.com/office/drawing/2014/main" id="{D5605236-F542-504E-86CE-5961DD6FF1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12391" y="1860152"/>
              <a:ext cx="140003" cy="3959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矢印コネクタ 21">
              <a:extLst>
                <a:ext uri="{FF2B5EF4-FFF2-40B4-BE49-F238E27FC236}">
                  <a16:creationId xmlns:a16="http://schemas.microsoft.com/office/drawing/2014/main" id="{E97BA4D9-2E97-2A4A-8F74-FF989204FD5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73015" y="1597700"/>
              <a:ext cx="179379" cy="6546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矢印コネクタ 22">
              <a:extLst>
                <a:ext uri="{FF2B5EF4-FFF2-40B4-BE49-F238E27FC236}">
                  <a16:creationId xmlns:a16="http://schemas.microsoft.com/office/drawing/2014/main" id="{1C2ABF7F-3DA9-494A-A3F7-038F3123D8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05335" y="2183966"/>
              <a:ext cx="200816" cy="4723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矢印コネクタ 23">
              <a:extLst>
                <a:ext uri="{FF2B5EF4-FFF2-40B4-BE49-F238E27FC236}">
                  <a16:creationId xmlns:a16="http://schemas.microsoft.com/office/drawing/2014/main" id="{A987E3BD-6272-C647-86B3-CC36C1BE949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85744" y="3976519"/>
              <a:ext cx="243153" cy="7096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A907E16C-6F91-AB42-85B1-9B3FC159104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31650" y="4841851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F761C4BB-0263-8445-8FDD-CA4DFD2856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65270" y="4982847"/>
              <a:ext cx="191490" cy="5750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A10BED0D-5864-2D43-B686-503F0F7418E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3314" y="5040355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id="{4C2C288C-8F1E-6343-A456-FCF8639AD5F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14999" y="4885394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矢印コネクタ 28">
              <a:extLst>
                <a:ext uri="{FF2B5EF4-FFF2-40B4-BE49-F238E27FC236}">
                  <a16:creationId xmlns:a16="http://schemas.microsoft.com/office/drawing/2014/main" id="{B221B6B0-9D4A-354B-9DE2-1A637B60EA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14999" y="5418382"/>
              <a:ext cx="213898" cy="18931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id="{88E3FE16-A505-B340-81C9-4610C0BF59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85224" y="5758037"/>
              <a:ext cx="123842" cy="16431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矢印コネクタ 30">
              <a:extLst>
                <a:ext uri="{FF2B5EF4-FFF2-40B4-BE49-F238E27FC236}">
                  <a16:creationId xmlns:a16="http://schemas.microsoft.com/office/drawing/2014/main" id="{64E9058B-3FE5-FD44-AFCC-59093DD162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45630" y="4414229"/>
              <a:ext cx="233752" cy="9315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id="{E07557CF-FC9E-A84E-B17E-B4589213C20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18191" y="4495734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矢印コネクタ 32">
              <a:extLst>
                <a:ext uri="{FF2B5EF4-FFF2-40B4-BE49-F238E27FC236}">
                  <a16:creationId xmlns:a16="http://schemas.microsoft.com/office/drawing/2014/main" id="{07E8048A-ED20-B648-8B19-2F22B0ADA9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58256" y="5983249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F2FD8FF3-1189-B347-AE9E-D742D53681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82392" y="6249518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76AD079D-109A-1549-B0B0-06282E2657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30731" y="6118971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id="{90EC9D56-8724-C54A-B2BE-48CC5246E7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55645" y="6468053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F92A28C1-0BD3-DB44-B534-44DDD1B3D08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076627" y="6301804"/>
              <a:ext cx="81114" cy="4396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8A7916BA-EA98-C149-86CE-152717DFE49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62337" y="5860748"/>
              <a:ext cx="108821" cy="6159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id="{2B817763-9032-CE4A-A3A5-22B59D5EBA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80439" y="5674884"/>
              <a:ext cx="131910" cy="10373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>
              <a:extLst>
                <a:ext uri="{FF2B5EF4-FFF2-40B4-BE49-F238E27FC236}">
                  <a16:creationId xmlns:a16="http://schemas.microsoft.com/office/drawing/2014/main" id="{837D9DD2-D65D-A04A-A1FF-57F5FC0EE68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821948" y="6578154"/>
              <a:ext cx="76824" cy="4140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83824C28-2D19-4D47-BFA9-E0EE342DBDD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940313" y="6868577"/>
              <a:ext cx="110859" cy="4773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矢印コネクタ 41">
              <a:extLst>
                <a:ext uri="{FF2B5EF4-FFF2-40B4-BE49-F238E27FC236}">
                  <a16:creationId xmlns:a16="http://schemas.microsoft.com/office/drawing/2014/main" id="{9685DFAB-9DA6-7E4E-96A0-A180741032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76694" y="5488092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矢印コネクタ 42">
              <a:extLst>
                <a:ext uri="{FF2B5EF4-FFF2-40B4-BE49-F238E27FC236}">
                  <a16:creationId xmlns:a16="http://schemas.microsoft.com/office/drawing/2014/main" id="{FE43807D-40FD-634D-97F1-B24CF00D95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76694" y="4982847"/>
              <a:ext cx="120477" cy="58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矢印コネクタ 43">
              <a:extLst>
                <a:ext uri="{FF2B5EF4-FFF2-40B4-BE49-F238E27FC236}">
                  <a16:creationId xmlns:a16="http://schemas.microsoft.com/office/drawing/2014/main" id="{8AC81EB7-53EB-2648-BC0D-13BE3115379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34242" y="5135247"/>
              <a:ext cx="120477" cy="58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矢印コネクタ 44">
              <a:extLst>
                <a:ext uri="{FF2B5EF4-FFF2-40B4-BE49-F238E27FC236}">
                  <a16:creationId xmlns:a16="http://schemas.microsoft.com/office/drawing/2014/main" id="{FBEA1DB5-2427-484D-88FA-B00AC9A99F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85267" y="5096757"/>
              <a:ext cx="85693" cy="58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矢印コネクタ 45">
              <a:extLst>
                <a:ext uri="{FF2B5EF4-FFF2-40B4-BE49-F238E27FC236}">
                  <a16:creationId xmlns:a16="http://schemas.microsoft.com/office/drawing/2014/main" id="{BBA6718C-493E-9344-9F9A-54373351B1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79139" y="5040355"/>
              <a:ext cx="131641" cy="17320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矢印コネクタ 46">
              <a:extLst>
                <a:ext uri="{FF2B5EF4-FFF2-40B4-BE49-F238E27FC236}">
                  <a16:creationId xmlns:a16="http://schemas.microsoft.com/office/drawing/2014/main" id="{17D5BBE7-001C-3248-BBD5-BBE09816BF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53723" y="4534847"/>
              <a:ext cx="95457" cy="8985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矢印コネクタ 47">
              <a:extLst>
                <a:ext uri="{FF2B5EF4-FFF2-40B4-BE49-F238E27FC236}">
                  <a16:creationId xmlns:a16="http://schemas.microsoft.com/office/drawing/2014/main" id="{F16554AB-0EE1-A945-BF14-D3BE229453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2433" y="4841851"/>
              <a:ext cx="158725" cy="4354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矢印コネクタ 48">
              <a:extLst>
                <a:ext uri="{FF2B5EF4-FFF2-40B4-BE49-F238E27FC236}">
                  <a16:creationId xmlns:a16="http://schemas.microsoft.com/office/drawing/2014/main" id="{1EAD3E99-66E4-8D47-8238-5B9B4E1125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8127" y="4885394"/>
              <a:ext cx="160947" cy="14797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矢印コネクタ 49">
              <a:extLst>
                <a:ext uri="{FF2B5EF4-FFF2-40B4-BE49-F238E27FC236}">
                  <a16:creationId xmlns:a16="http://schemas.microsoft.com/office/drawing/2014/main" id="{838FD81C-91B0-3C4A-9CD4-41228C8716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6329" y="5033372"/>
              <a:ext cx="168319" cy="10187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矢印コネクタ 50">
              <a:extLst>
                <a:ext uri="{FF2B5EF4-FFF2-40B4-BE49-F238E27FC236}">
                  <a16:creationId xmlns:a16="http://schemas.microsoft.com/office/drawing/2014/main" id="{58EC14F6-7B1A-554E-90E7-ABF65D237C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0489" y="4666540"/>
              <a:ext cx="84159" cy="8972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矢印コネクタ 51">
              <a:extLst>
                <a:ext uri="{FF2B5EF4-FFF2-40B4-BE49-F238E27FC236}">
                  <a16:creationId xmlns:a16="http://schemas.microsoft.com/office/drawing/2014/main" id="{DA2435B1-0BD2-DC40-9BBB-E0EA8BB04C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3563" y="4309978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矢印コネクタ 52">
              <a:extLst>
                <a:ext uri="{FF2B5EF4-FFF2-40B4-BE49-F238E27FC236}">
                  <a16:creationId xmlns:a16="http://schemas.microsoft.com/office/drawing/2014/main" id="{9D04C382-C098-7A4D-B680-F0F16B9944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85745" y="4460564"/>
              <a:ext cx="76333" cy="1452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矢印コネクタ 53">
              <a:extLst>
                <a:ext uri="{FF2B5EF4-FFF2-40B4-BE49-F238E27FC236}">
                  <a16:creationId xmlns:a16="http://schemas.microsoft.com/office/drawing/2014/main" id="{7F4D3548-8D51-9641-AE91-7E0FFA1817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47313" y="960815"/>
              <a:ext cx="153080" cy="17334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>
              <a:extLst>
                <a:ext uri="{FF2B5EF4-FFF2-40B4-BE49-F238E27FC236}">
                  <a16:creationId xmlns:a16="http://schemas.microsoft.com/office/drawing/2014/main" id="{9D8455B6-A310-0A49-8538-83E658CD772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26302" y="1047489"/>
              <a:ext cx="153080" cy="13007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>
              <a:extLst>
                <a:ext uri="{FF2B5EF4-FFF2-40B4-BE49-F238E27FC236}">
                  <a16:creationId xmlns:a16="http://schemas.microsoft.com/office/drawing/2014/main" id="{37C96786-ED66-724E-8457-3FD41EB1FF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13427" y="1245430"/>
              <a:ext cx="157685" cy="6220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矢印コネクタ 56">
              <a:extLst>
                <a:ext uri="{FF2B5EF4-FFF2-40B4-BE49-F238E27FC236}">
                  <a16:creationId xmlns:a16="http://schemas.microsoft.com/office/drawing/2014/main" id="{F57D18E1-188B-6147-BB7E-FCE5171D39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10780" y="1874164"/>
              <a:ext cx="221315" cy="1227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矢印コネクタ 57">
              <a:extLst>
                <a:ext uri="{FF2B5EF4-FFF2-40B4-BE49-F238E27FC236}">
                  <a16:creationId xmlns:a16="http://schemas.microsoft.com/office/drawing/2014/main" id="{74085322-1930-C549-9D75-E80A32A96A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75654" y="2140579"/>
              <a:ext cx="121930" cy="693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矢印コネクタ 58">
              <a:extLst>
                <a:ext uri="{FF2B5EF4-FFF2-40B4-BE49-F238E27FC236}">
                  <a16:creationId xmlns:a16="http://schemas.microsoft.com/office/drawing/2014/main" id="{79001539-448C-7E4A-B397-F5DF4B34509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55645" y="1410333"/>
              <a:ext cx="215410" cy="5040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矢印コネクタ 59">
              <a:extLst>
                <a:ext uri="{FF2B5EF4-FFF2-40B4-BE49-F238E27FC236}">
                  <a16:creationId xmlns:a16="http://schemas.microsoft.com/office/drawing/2014/main" id="{4748BC29-6189-4B41-A027-3EAE850F7C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24889" y="1382241"/>
              <a:ext cx="196548" cy="4503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矢印コネクタ 60">
              <a:extLst>
                <a:ext uri="{FF2B5EF4-FFF2-40B4-BE49-F238E27FC236}">
                  <a16:creationId xmlns:a16="http://schemas.microsoft.com/office/drawing/2014/main" id="{86F2849D-1414-E948-9979-EE75F9730B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55610" y="1375504"/>
              <a:ext cx="206468" cy="7192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矢印コネクタ 61">
              <a:extLst>
                <a:ext uri="{FF2B5EF4-FFF2-40B4-BE49-F238E27FC236}">
                  <a16:creationId xmlns:a16="http://schemas.microsoft.com/office/drawing/2014/main" id="{F81AE00A-BB64-DB47-AB35-1E371ED42F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08901" y="1630430"/>
              <a:ext cx="112835" cy="6647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矢印コネクタ 62">
              <a:extLst>
                <a:ext uri="{FF2B5EF4-FFF2-40B4-BE49-F238E27FC236}">
                  <a16:creationId xmlns:a16="http://schemas.microsoft.com/office/drawing/2014/main" id="{F306F412-5ED5-DC4A-85F9-AF465EB7060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22091" y="4074654"/>
              <a:ext cx="230323" cy="8299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矢印コネクタ 63">
              <a:extLst>
                <a:ext uri="{FF2B5EF4-FFF2-40B4-BE49-F238E27FC236}">
                  <a16:creationId xmlns:a16="http://schemas.microsoft.com/office/drawing/2014/main" id="{08D31C52-E349-D54B-B25B-CE58FCB25B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70853" y="4460564"/>
              <a:ext cx="78526" cy="13215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矢印コネクタ 64">
              <a:extLst>
                <a:ext uri="{FF2B5EF4-FFF2-40B4-BE49-F238E27FC236}">
                  <a16:creationId xmlns:a16="http://schemas.microsoft.com/office/drawing/2014/main" id="{3FAEC1F0-BF18-4A4C-8DCD-38F3B8A52B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10538" y="4495734"/>
              <a:ext cx="84083" cy="17080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矢印コネクタ 65">
              <a:extLst>
                <a:ext uri="{FF2B5EF4-FFF2-40B4-BE49-F238E27FC236}">
                  <a16:creationId xmlns:a16="http://schemas.microsoft.com/office/drawing/2014/main" id="{B69547D5-2A68-544B-A189-6B6F48C8D4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24682" y="4756670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矢印コネクタ 66">
              <a:extLst>
                <a:ext uri="{FF2B5EF4-FFF2-40B4-BE49-F238E27FC236}">
                  <a16:creationId xmlns:a16="http://schemas.microsoft.com/office/drawing/2014/main" id="{06AFCB77-460F-3843-94E8-7E1CEF9C55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99283" y="4636610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矢印コネクタ 67">
              <a:extLst>
                <a:ext uri="{FF2B5EF4-FFF2-40B4-BE49-F238E27FC236}">
                  <a16:creationId xmlns:a16="http://schemas.microsoft.com/office/drawing/2014/main" id="{DA5C51C2-975C-DE42-8A70-8DDB3693A6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69858" y="5011601"/>
              <a:ext cx="73204" cy="3621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矢印コネクタ 68">
              <a:extLst>
                <a:ext uri="{FF2B5EF4-FFF2-40B4-BE49-F238E27FC236}">
                  <a16:creationId xmlns:a16="http://schemas.microsoft.com/office/drawing/2014/main" id="{BEC1C84C-0588-944D-9B9B-57C4A4CE1D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80586" y="5165847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矢印コネクタ 69">
              <a:extLst>
                <a:ext uri="{FF2B5EF4-FFF2-40B4-BE49-F238E27FC236}">
                  <a16:creationId xmlns:a16="http://schemas.microsoft.com/office/drawing/2014/main" id="{4AD17CC4-AADE-DF49-B59F-6ACA7CC1DA4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09066" y="3443532"/>
              <a:ext cx="149778" cy="9198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矢印コネクタ 70">
              <a:extLst>
                <a:ext uri="{FF2B5EF4-FFF2-40B4-BE49-F238E27FC236}">
                  <a16:creationId xmlns:a16="http://schemas.microsoft.com/office/drawing/2014/main" id="{EA9D63E8-C183-5541-9E24-95E57961E37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3277" y="2075557"/>
              <a:ext cx="121203" cy="3983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矢印コネクタ 71">
              <a:extLst>
                <a:ext uri="{FF2B5EF4-FFF2-40B4-BE49-F238E27FC236}">
                  <a16:creationId xmlns:a16="http://schemas.microsoft.com/office/drawing/2014/main" id="{4FA15ADA-3215-E049-B7AF-374C2ECFBEA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94905" y="1781455"/>
              <a:ext cx="115211" cy="7869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矢印コネクタ 72">
              <a:extLst>
                <a:ext uri="{FF2B5EF4-FFF2-40B4-BE49-F238E27FC236}">
                  <a16:creationId xmlns:a16="http://schemas.microsoft.com/office/drawing/2014/main" id="{ED80C88B-02FA-5B4B-9ADC-FB3C74995A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57207" y="1843263"/>
              <a:ext cx="126933" cy="29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矢印コネクタ 73">
              <a:extLst>
                <a:ext uri="{FF2B5EF4-FFF2-40B4-BE49-F238E27FC236}">
                  <a16:creationId xmlns:a16="http://schemas.microsoft.com/office/drawing/2014/main" id="{D0FF98CC-43B2-4045-90A2-69CEFC91AB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91796" y="3102148"/>
              <a:ext cx="183185" cy="4778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矢印コネクタ 74">
              <a:extLst>
                <a:ext uri="{FF2B5EF4-FFF2-40B4-BE49-F238E27FC236}">
                  <a16:creationId xmlns:a16="http://schemas.microsoft.com/office/drawing/2014/main" id="{C35FBFF7-7090-1A4F-B6FA-C41FD73E23C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33922" y="4372901"/>
              <a:ext cx="128377" cy="6396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矢印コネクタ 75">
              <a:extLst>
                <a:ext uri="{FF2B5EF4-FFF2-40B4-BE49-F238E27FC236}">
                  <a16:creationId xmlns:a16="http://schemas.microsoft.com/office/drawing/2014/main" id="{52319573-AB93-034C-A32E-CE5FA6C8CF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16380" y="5366689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矢印コネクタ 76">
              <a:extLst>
                <a:ext uri="{FF2B5EF4-FFF2-40B4-BE49-F238E27FC236}">
                  <a16:creationId xmlns:a16="http://schemas.microsoft.com/office/drawing/2014/main" id="{C84F8D00-CCFC-6640-8025-125BA96EB1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10538" y="5912615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矢印コネクタ 77">
              <a:extLst>
                <a:ext uri="{FF2B5EF4-FFF2-40B4-BE49-F238E27FC236}">
                  <a16:creationId xmlns:a16="http://schemas.microsoft.com/office/drawing/2014/main" id="{42E9545E-4420-354D-80B1-D4B1AF57D0E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36932" y="5899808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矢印コネクタ 78">
              <a:extLst>
                <a:ext uri="{FF2B5EF4-FFF2-40B4-BE49-F238E27FC236}">
                  <a16:creationId xmlns:a16="http://schemas.microsoft.com/office/drawing/2014/main" id="{5F5832C2-E3D3-4A48-987E-77F6A1D2FBE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32340" y="6108855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矢印コネクタ 79">
              <a:extLst>
                <a:ext uri="{FF2B5EF4-FFF2-40B4-BE49-F238E27FC236}">
                  <a16:creationId xmlns:a16="http://schemas.microsoft.com/office/drawing/2014/main" id="{760726F5-87D3-CE49-B9F7-FD35EEB81C9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49379" y="6326406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矢印コネクタ 80">
              <a:extLst>
                <a:ext uri="{FF2B5EF4-FFF2-40B4-BE49-F238E27FC236}">
                  <a16:creationId xmlns:a16="http://schemas.microsoft.com/office/drawing/2014/main" id="{E75F7DE9-4B73-9745-A9E3-80E0A387EE4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18239" y="6124137"/>
              <a:ext cx="10349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矢印コネクタ 81">
              <a:extLst>
                <a:ext uri="{FF2B5EF4-FFF2-40B4-BE49-F238E27FC236}">
                  <a16:creationId xmlns:a16="http://schemas.microsoft.com/office/drawing/2014/main" id="{2DB31FAE-849B-5E45-80CA-E1F2222F6D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973585" y="6049445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矢印コネクタ 82">
              <a:extLst>
                <a:ext uri="{FF2B5EF4-FFF2-40B4-BE49-F238E27FC236}">
                  <a16:creationId xmlns:a16="http://schemas.microsoft.com/office/drawing/2014/main" id="{B7B4933E-483D-4A4B-BFED-D0BDA42124F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52204" y="6124174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矢印コネクタ 83">
              <a:extLst>
                <a:ext uri="{FF2B5EF4-FFF2-40B4-BE49-F238E27FC236}">
                  <a16:creationId xmlns:a16="http://schemas.microsoft.com/office/drawing/2014/main" id="{AB501F17-E65C-1247-BEC3-95168E492AF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40842" y="6294666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矢印コネクタ 84">
              <a:extLst>
                <a:ext uri="{FF2B5EF4-FFF2-40B4-BE49-F238E27FC236}">
                  <a16:creationId xmlns:a16="http://schemas.microsoft.com/office/drawing/2014/main" id="{BD593D37-2ADD-104A-83AA-BFDEB9AC25B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77610" y="6098523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矢印コネクタ 85">
              <a:extLst>
                <a:ext uri="{FF2B5EF4-FFF2-40B4-BE49-F238E27FC236}">
                  <a16:creationId xmlns:a16="http://schemas.microsoft.com/office/drawing/2014/main" id="{8063BE17-0470-B547-9842-7A16376B5B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66857" y="6897609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矢印コネクタ 86">
              <a:extLst>
                <a:ext uri="{FF2B5EF4-FFF2-40B4-BE49-F238E27FC236}">
                  <a16:creationId xmlns:a16="http://schemas.microsoft.com/office/drawing/2014/main" id="{27EECCA8-FA0F-404D-8950-C2E46A8F194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23911" y="6883071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矢印コネクタ 87">
              <a:extLst>
                <a:ext uri="{FF2B5EF4-FFF2-40B4-BE49-F238E27FC236}">
                  <a16:creationId xmlns:a16="http://schemas.microsoft.com/office/drawing/2014/main" id="{D6699C13-526F-AF49-837B-92CB48CF41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74314" y="5504224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矢印コネクタ 88">
              <a:extLst>
                <a:ext uri="{FF2B5EF4-FFF2-40B4-BE49-F238E27FC236}">
                  <a16:creationId xmlns:a16="http://schemas.microsoft.com/office/drawing/2014/main" id="{9E1CCE35-8F86-0F40-962C-F60AF829797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501898" y="5366689"/>
              <a:ext cx="103323" cy="1036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矢印コネクタ 89">
              <a:extLst>
                <a:ext uri="{FF2B5EF4-FFF2-40B4-BE49-F238E27FC236}">
                  <a16:creationId xmlns:a16="http://schemas.microsoft.com/office/drawing/2014/main" id="{3637314F-762D-794C-A5A6-FA017A10C79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82712" y="5498281"/>
              <a:ext cx="87599" cy="442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矢印コネクタ 90">
              <a:extLst>
                <a:ext uri="{FF2B5EF4-FFF2-40B4-BE49-F238E27FC236}">
                  <a16:creationId xmlns:a16="http://schemas.microsoft.com/office/drawing/2014/main" id="{421B8C5B-87A4-5648-928B-10437B8C610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66750" y="4790252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矢印コネクタ 91">
              <a:extLst>
                <a:ext uri="{FF2B5EF4-FFF2-40B4-BE49-F238E27FC236}">
                  <a16:creationId xmlns:a16="http://schemas.microsoft.com/office/drawing/2014/main" id="{7EFACEB0-8DA2-FB46-9E9A-73B5AC58C1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03652" y="4767008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矢印コネクタ 92">
              <a:extLst>
                <a:ext uri="{FF2B5EF4-FFF2-40B4-BE49-F238E27FC236}">
                  <a16:creationId xmlns:a16="http://schemas.microsoft.com/office/drawing/2014/main" id="{F2DC5414-C993-BD46-BFBF-C86CB35C6D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66384" y="4800590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矢印コネクタ 93">
              <a:extLst>
                <a:ext uri="{FF2B5EF4-FFF2-40B4-BE49-F238E27FC236}">
                  <a16:creationId xmlns:a16="http://schemas.microsoft.com/office/drawing/2014/main" id="{DEE171AE-165E-4B47-BDB3-E1774E2AF4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20630" y="4606861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矢印コネクタ 94">
              <a:extLst>
                <a:ext uri="{FF2B5EF4-FFF2-40B4-BE49-F238E27FC236}">
                  <a16:creationId xmlns:a16="http://schemas.microsoft.com/office/drawing/2014/main" id="{C1D6C221-59CD-6C4B-9230-2A645752A9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21003" y="5638689"/>
              <a:ext cx="123336" cy="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矢印コネクタ 95">
              <a:extLst>
                <a:ext uri="{FF2B5EF4-FFF2-40B4-BE49-F238E27FC236}">
                  <a16:creationId xmlns:a16="http://schemas.microsoft.com/office/drawing/2014/main" id="{F2730A45-49F7-5444-B8AE-FC4F693D472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87594" y="3146074"/>
              <a:ext cx="104675" cy="175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矢印コネクタ 96">
              <a:extLst>
                <a:ext uri="{FF2B5EF4-FFF2-40B4-BE49-F238E27FC236}">
                  <a16:creationId xmlns:a16="http://schemas.microsoft.com/office/drawing/2014/main" id="{D5DF6D20-51CB-DA4D-8653-930E4B8FF7E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58793" y="3231223"/>
              <a:ext cx="1416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矢印コネクタ 97">
              <a:extLst>
                <a:ext uri="{FF2B5EF4-FFF2-40B4-BE49-F238E27FC236}">
                  <a16:creationId xmlns:a16="http://schemas.microsoft.com/office/drawing/2014/main" id="{5C1FD182-BDD4-0C4D-94E4-BC9FAB003D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84140" y="2875623"/>
              <a:ext cx="1416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矢印コネクタ 98">
              <a:extLst>
                <a:ext uri="{FF2B5EF4-FFF2-40B4-BE49-F238E27FC236}">
                  <a16:creationId xmlns:a16="http://schemas.microsoft.com/office/drawing/2014/main" id="{49FA75CE-941C-7C42-A484-0C631993E4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18191" y="3906122"/>
              <a:ext cx="238569" cy="7039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矢印コネクタ 99">
              <a:extLst>
                <a:ext uri="{FF2B5EF4-FFF2-40B4-BE49-F238E27FC236}">
                  <a16:creationId xmlns:a16="http://schemas.microsoft.com/office/drawing/2014/main" id="{4C39E6AD-34B4-7341-B5C6-6667D03D6F4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61155" y="3655297"/>
              <a:ext cx="157036" cy="5584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矢印コネクタ 100">
              <a:extLst>
                <a:ext uri="{FF2B5EF4-FFF2-40B4-BE49-F238E27FC236}">
                  <a16:creationId xmlns:a16="http://schemas.microsoft.com/office/drawing/2014/main" id="{500E9D71-BB50-0848-A74B-FE95F5BC827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516747" y="1569322"/>
              <a:ext cx="87012" cy="6463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矢印コネクタ 101">
              <a:extLst>
                <a:ext uri="{FF2B5EF4-FFF2-40B4-BE49-F238E27FC236}">
                  <a16:creationId xmlns:a16="http://schemas.microsoft.com/office/drawing/2014/main" id="{7B6F3F8A-7DCD-7447-9F24-47C7E48F95D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85489" y="5576172"/>
              <a:ext cx="99590" cy="11120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矢印コネクタ 102">
              <a:extLst>
                <a:ext uri="{FF2B5EF4-FFF2-40B4-BE49-F238E27FC236}">
                  <a16:creationId xmlns:a16="http://schemas.microsoft.com/office/drawing/2014/main" id="{22053F7D-A8E3-D948-A47C-6719D09827D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02842" y="5576172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矢印コネクタ 103">
              <a:extLst>
                <a:ext uri="{FF2B5EF4-FFF2-40B4-BE49-F238E27FC236}">
                  <a16:creationId xmlns:a16="http://schemas.microsoft.com/office/drawing/2014/main" id="{28E0346E-E86E-254B-8D91-D50C775D630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17673" y="5674884"/>
              <a:ext cx="137972" cy="3599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矢印コネクタ 104">
              <a:extLst>
                <a:ext uri="{FF2B5EF4-FFF2-40B4-BE49-F238E27FC236}">
                  <a16:creationId xmlns:a16="http://schemas.microsoft.com/office/drawing/2014/main" id="{145492C4-9DEA-D94A-B9B2-A29A1E4FCBE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9907" y="6805534"/>
              <a:ext cx="10481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矢印コネクタ 105">
              <a:extLst>
                <a:ext uri="{FF2B5EF4-FFF2-40B4-BE49-F238E27FC236}">
                  <a16:creationId xmlns:a16="http://schemas.microsoft.com/office/drawing/2014/main" id="{670C60CB-89CA-BF40-8BFA-61DAB6CBD7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5307" y="7055722"/>
              <a:ext cx="79418" cy="292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矢印コネクタ 106">
              <a:extLst>
                <a:ext uri="{FF2B5EF4-FFF2-40B4-BE49-F238E27FC236}">
                  <a16:creationId xmlns:a16="http://schemas.microsoft.com/office/drawing/2014/main" id="{654406A5-D604-A748-BD5E-4D17052ECFD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4649" y="2530165"/>
              <a:ext cx="94326" cy="4232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矢印コネクタ 107">
              <a:extLst>
                <a:ext uri="{FF2B5EF4-FFF2-40B4-BE49-F238E27FC236}">
                  <a16:creationId xmlns:a16="http://schemas.microsoft.com/office/drawing/2014/main" id="{CF1A353D-F8D9-5E4B-9867-C3F7B77EDF5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34459" y="3270733"/>
              <a:ext cx="150808" cy="10841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矢印コネクタ 108">
              <a:extLst>
                <a:ext uri="{FF2B5EF4-FFF2-40B4-BE49-F238E27FC236}">
                  <a16:creationId xmlns:a16="http://schemas.microsoft.com/office/drawing/2014/main" id="{AD97D02C-B29A-CF44-AA58-76D67355353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5233" y="3032766"/>
              <a:ext cx="104674" cy="175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矢印コネクタ 109">
              <a:extLst>
                <a:ext uri="{FF2B5EF4-FFF2-40B4-BE49-F238E27FC236}">
                  <a16:creationId xmlns:a16="http://schemas.microsoft.com/office/drawing/2014/main" id="{23C709EC-C09F-EF47-9A2D-D2DA449C0E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85224" y="4835095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矢印コネクタ 110">
              <a:extLst>
                <a:ext uri="{FF2B5EF4-FFF2-40B4-BE49-F238E27FC236}">
                  <a16:creationId xmlns:a16="http://schemas.microsoft.com/office/drawing/2014/main" id="{38703999-F0A1-B247-BABD-2F4987D3172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57884" y="4113565"/>
              <a:ext cx="125679" cy="5546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矢印コネクタ 111">
              <a:extLst>
                <a:ext uri="{FF2B5EF4-FFF2-40B4-BE49-F238E27FC236}">
                  <a16:creationId xmlns:a16="http://schemas.microsoft.com/office/drawing/2014/main" id="{B0EBAFE6-8428-A841-AC66-820F494146A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43062" y="6206724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矢印コネクタ 112">
              <a:extLst>
                <a:ext uri="{FF2B5EF4-FFF2-40B4-BE49-F238E27FC236}">
                  <a16:creationId xmlns:a16="http://schemas.microsoft.com/office/drawing/2014/main" id="{C0738EA5-15F9-4C46-9FC7-72D82366C66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64666" y="6313468"/>
              <a:ext cx="131670" cy="2063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矢印コネクタ 113">
              <a:extLst>
                <a:ext uri="{FF2B5EF4-FFF2-40B4-BE49-F238E27FC236}">
                  <a16:creationId xmlns:a16="http://schemas.microsoft.com/office/drawing/2014/main" id="{682E8F26-52A3-3F41-9761-8C5CD9C74B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36159" y="5860748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矢印コネクタ 114">
              <a:extLst>
                <a:ext uri="{FF2B5EF4-FFF2-40B4-BE49-F238E27FC236}">
                  <a16:creationId xmlns:a16="http://schemas.microsoft.com/office/drawing/2014/main" id="{4897DB31-2B70-BB40-A40E-B6BB6EF998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50181" y="6722347"/>
              <a:ext cx="94158" cy="3682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矢印コネクタ 115">
              <a:extLst>
                <a:ext uri="{FF2B5EF4-FFF2-40B4-BE49-F238E27FC236}">
                  <a16:creationId xmlns:a16="http://schemas.microsoft.com/office/drawing/2014/main" id="{1A85C00A-9A3D-E84A-ADA3-90E40E4745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56023" y="6827221"/>
              <a:ext cx="94158" cy="3682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矢印コネクタ 116">
              <a:extLst>
                <a:ext uri="{FF2B5EF4-FFF2-40B4-BE49-F238E27FC236}">
                  <a16:creationId xmlns:a16="http://schemas.microsoft.com/office/drawing/2014/main" id="{79AB2AB1-E277-624B-BAD9-E0759E73A12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03652" y="6722347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矢印コネクタ 117">
              <a:extLst>
                <a:ext uri="{FF2B5EF4-FFF2-40B4-BE49-F238E27FC236}">
                  <a16:creationId xmlns:a16="http://schemas.microsoft.com/office/drawing/2014/main" id="{D57EEA09-9B7E-BD43-B6CF-77FCF94393D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721967" y="6468053"/>
              <a:ext cx="106146" cy="3521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矢印コネクタ 118">
              <a:extLst>
                <a:ext uri="{FF2B5EF4-FFF2-40B4-BE49-F238E27FC236}">
                  <a16:creationId xmlns:a16="http://schemas.microsoft.com/office/drawing/2014/main" id="{7768B872-690E-CF4E-826C-80193D66B6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30270" y="5369719"/>
              <a:ext cx="109993" cy="9732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矢印コネクタ 119">
              <a:extLst>
                <a:ext uri="{FF2B5EF4-FFF2-40B4-BE49-F238E27FC236}">
                  <a16:creationId xmlns:a16="http://schemas.microsoft.com/office/drawing/2014/main" id="{D0E56A13-CEB3-1947-8748-5AD8484D75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22091" y="5885874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矢印コネクタ 120">
              <a:extLst>
                <a:ext uri="{FF2B5EF4-FFF2-40B4-BE49-F238E27FC236}">
                  <a16:creationId xmlns:a16="http://schemas.microsoft.com/office/drawing/2014/main" id="{02C479D8-BB47-B343-A88A-56D1590D96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69541" y="2043713"/>
              <a:ext cx="188343" cy="27532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矢印コネクタ 121">
              <a:extLst>
                <a:ext uri="{FF2B5EF4-FFF2-40B4-BE49-F238E27FC236}">
                  <a16:creationId xmlns:a16="http://schemas.microsoft.com/office/drawing/2014/main" id="{087F2A69-A788-764D-93CD-459C4ED03F0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62506" y="2319034"/>
              <a:ext cx="95379" cy="4153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矢印コネクタ 122">
              <a:extLst>
                <a:ext uri="{FF2B5EF4-FFF2-40B4-BE49-F238E27FC236}">
                  <a16:creationId xmlns:a16="http://schemas.microsoft.com/office/drawing/2014/main" id="{3485C666-37E0-9C4F-B6E2-5E5D400167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4033" y="6424534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矢印コネクタ 123">
              <a:extLst>
                <a:ext uri="{FF2B5EF4-FFF2-40B4-BE49-F238E27FC236}">
                  <a16:creationId xmlns:a16="http://schemas.microsoft.com/office/drawing/2014/main" id="{51CF5DD5-293C-0348-9B94-C46B91D4DF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31650" y="6619562"/>
              <a:ext cx="137892" cy="10278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矢印コネクタ 124">
              <a:extLst>
                <a:ext uri="{FF2B5EF4-FFF2-40B4-BE49-F238E27FC236}">
                  <a16:creationId xmlns:a16="http://schemas.microsoft.com/office/drawing/2014/main" id="{D878A8A8-21B9-8343-9151-2AB4472131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92270" y="2242067"/>
              <a:ext cx="325799" cy="16149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矢印コネクタ 125">
              <a:extLst>
                <a:ext uri="{FF2B5EF4-FFF2-40B4-BE49-F238E27FC236}">
                  <a16:creationId xmlns:a16="http://schemas.microsoft.com/office/drawing/2014/main" id="{990FD06F-6343-9045-901E-65BCF69F66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85335" y="1083884"/>
              <a:ext cx="1247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矢印コネクタ 126">
              <a:extLst>
                <a:ext uri="{FF2B5EF4-FFF2-40B4-BE49-F238E27FC236}">
                  <a16:creationId xmlns:a16="http://schemas.microsoft.com/office/drawing/2014/main" id="{438F9FDB-5997-6C4F-A060-B4EE66C0D7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13360" y="1307637"/>
              <a:ext cx="6605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矢印コネクタ 127">
              <a:extLst>
                <a:ext uri="{FF2B5EF4-FFF2-40B4-BE49-F238E27FC236}">
                  <a16:creationId xmlns:a16="http://schemas.microsoft.com/office/drawing/2014/main" id="{FF259234-011E-774E-A0CB-1F5AA002248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65761" y="1526712"/>
              <a:ext cx="9769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矢印コネクタ 128">
              <a:extLst>
                <a:ext uri="{FF2B5EF4-FFF2-40B4-BE49-F238E27FC236}">
                  <a16:creationId xmlns:a16="http://schemas.microsoft.com/office/drawing/2014/main" id="{F41D5ABE-B587-EF46-A0AC-4867A66E5FF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59595" y="931147"/>
              <a:ext cx="107155" cy="2515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矢印コネクタ 129">
              <a:extLst>
                <a:ext uri="{FF2B5EF4-FFF2-40B4-BE49-F238E27FC236}">
                  <a16:creationId xmlns:a16="http://schemas.microsoft.com/office/drawing/2014/main" id="{7C7E7BEE-A65F-8544-A25A-C860A02237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51021" y="1112526"/>
              <a:ext cx="9769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線矢印コネクタ 130">
              <a:extLst>
                <a:ext uri="{FF2B5EF4-FFF2-40B4-BE49-F238E27FC236}">
                  <a16:creationId xmlns:a16="http://schemas.microsoft.com/office/drawing/2014/main" id="{E0600934-6C6B-F645-9E99-51605BB5AC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95234" y="2242067"/>
              <a:ext cx="170527" cy="4804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矢印コネクタ 131">
              <a:extLst>
                <a:ext uri="{FF2B5EF4-FFF2-40B4-BE49-F238E27FC236}">
                  <a16:creationId xmlns:a16="http://schemas.microsoft.com/office/drawing/2014/main" id="{A61F23CE-DB67-8A41-AE37-F7417C0E7E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41988" y="3754347"/>
              <a:ext cx="184510" cy="5280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矢印コネクタ 132">
              <a:extLst>
                <a:ext uri="{FF2B5EF4-FFF2-40B4-BE49-F238E27FC236}">
                  <a16:creationId xmlns:a16="http://schemas.microsoft.com/office/drawing/2014/main" id="{DE449947-F9A8-BE4B-A58E-4E9581F6D52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5136" y="1627609"/>
              <a:ext cx="100920" cy="4457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矢印コネクタ 133">
              <a:extLst>
                <a:ext uri="{FF2B5EF4-FFF2-40B4-BE49-F238E27FC236}">
                  <a16:creationId xmlns:a16="http://schemas.microsoft.com/office/drawing/2014/main" id="{04EA04C5-A2EA-0E45-8D85-78C7F335F6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30695" y="5414313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矢印コネクタ 134">
              <a:extLst>
                <a:ext uri="{FF2B5EF4-FFF2-40B4-BE49-F238E27FC236}">
                  <a16:creationId xmlns:a16="http://schemas.microsoft.com/office/drawing/2014/main" id="{75B3C126-CA5C-DD4E-A943-5751EA421A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68806" y="5642916"/>
              <a:ext cx="9415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矢印コネクタ 135">
              <a:extLst>
                <a:ext uri="{FF2B5EF4-FFF2-40B4-BE49-F238E27FC236}">
                  <a16:creationId xmlns:a16="http://schemas.microsoft.com/office/drawing/2014/main" id="{830ECE43-6FDF-DC46-BCD2-37C9F36C14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00844" y="2065421"/>
              <a:ext cx="124045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線矢印コネクタ 136">
              <a:extLst>
                <a:ext uri="{FF2B5EF4-FFF2-40B4-BE49-F238E27FC236}">
                  <a16:creationId xmlns:a16="http://schemas.microsoft.com/office/drawing/2014/main" id="{3BB0109D-B342-8F43-B830-41EACB0DE4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03896" y="2023451"/>
              <a:ext cx="236113" cy="15842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直線矢印コネクタ 137">
              <a:extLst>
                <a:ext uri="{FF2B5EF4-FFF2-40B4-BE49-F238E27FC236}">
                  <a16:creationId xmlns:a16="http://schemas.microsoft.com/office/drawing/2014/main" id="{0D660070-2102-6842-9E83-B2A719B8C2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24000" y="4959383"/>
              <a:ext cx="133741" cy="20546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線矢印コネクタ 138">
              <a:extLst>
                <a:ext uri="{FF2B5EF4-FFF2-40B4-BE49-F238E27FC236}">
                  <a16:creationId xmlns:a16="http://schemas.microsoft.com/office/drawing/2014/main" id="{ECF4D344-9415-A24F-9F7B-09A7335C1E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51607" y="5121846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線矢印コネクタ 139">
              <a:extLst>
                <a:ext uri="{FF2B5EF4-FFF2-40B4-BE49-F238E27FC236}">
                  <a16:creationId xmlns:a16="http://schemas.microsoft.com/office/drawing/2014/main" id="{8ABA032A-B0A1-4147-B554-68DF74B9F2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62782" y="4708225"/>
              <a:ext cx="85643" cy="4486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線矢印コネクタ 140">
              <a:extLst>
                <a:ext uri="{FF2B5EF4-FFF2-40B4-BE49-F238E27FC236}">
                  <a16:creationId xmlns:a16="http://schemas.microsoft.com/office/drawing/2014/main" id="{8AAE2954-90F7-B34F-954B-1B392E3A9B4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72282" y="5513037"/>
              <a:ext cx="9035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線矢印コネクタ 141">
              <a:extLst>
                <a:ext uri="{FF2B5EF4-FFF2-40B4-BE49-F238E27FC236}">
                  <a16:creationId xmlns:a16="http://schemas.microsoft.com/office/drawing/2014/main" id="{627D928E-EB47-1246-BE2E-201CDF8493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33071" y="4959383"/>
              <a:ext cx="144539" cy="8097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線矢印コネクタ 142">
              <a:extLst>
                <a:ext uri="{FF2B5EF4-FFF2-40B4-BE49-F238E27FC236}">
                  <a16:creationId xmlns:a16="http://schemas.microsoft.com/office/drawing/2014/main" id="{C0947A9B-C2DF-0544-99AD-46105268D4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9974" y="3374053"/>
              <a:ext cx="199001" cy="5004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直線矢印コネクタ 143">
              <a:extLst>
                <a:ext uri="{FF2B5EF4-FFF2-40B4-BE49-F238E27FC236}">
                  <a16:creationId xmlns:a16="http://schemas.microsoft.com/office/drawing/2014/main" id="{EBB8096D-5275-5C42-B69A-D2BAD89C19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0080" y="3443532"/>
              <a:ext cx="159570" cy="9198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線矢印コネクタ 144">
              <a:extLst>
                <a:ext uri="{FF2B5EF4-FFF2-40B4-BE49-F238E27FC236}">
                  <a16:creationId xmlns:a16="http://schemas.microsoft.com/office/drawing/2014/main" id="{C15BDAC4-39D0-294B-9BC2-1BB6546DA3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05900" y="3997575"/>
              <a:ext cx="95342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矢印コネクタ 145">
              <a:extLst>
                <a:ext uri="{FF2B5EF4-FFF2-40B4-BE49-F238E27FC236}">
                  <a16:creationId xmlns:a16="http://schemas.microsoft.com/office/drawing/2014/main" id="{D9543D94-C431-E949-8A8D-2298439611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25322" y="3589887"/>
              <a:ext cx="121300" cy="792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線矢印コネクタ 146">
              <a:extLst>
                <a:ext uri="{FF2B5EF4-FFF2-40B4-BE49-F238E27FC236}">
                  <a16:creationId xmlns:a16="http://schemas.microsoft.com/office/drawing/2014/main" id="{234E9F33-6B53-BE44-9061-1AFC95E8D2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02623" y="2385932"/>
              <a:ext cx="241716" cy="41969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線矢印コネクタ 147">
              <a:extLst>
                <a:ext uri="{FF2B5EF4-FFF2-40B4-BE49-F238E27FC236}">
                  <a16:creationId xmlns:a16="http://schemas.microsoft.com/office/drawing/2014/main" id="{162663D8-B39A-474C-9042-886A858266D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24090" y="2075557"/>
              <a:ext cx="128032" cy="35567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線矢印コネクタ 148">
              <a:extLst>
                <a:ext uri="{FF2B5EF4-FFF2-40B4-BE49-F238E27FC236}">
                  <a16:creationId xmlns:a16="http://schemas.microsoft.com/office/drawing/2014/main" id="{2EC898C6-D4C6-3B4D-BE82-3B5C6839A39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42878" y="1701373"/>
              <a:ext cx="83892" cy="152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矢印コネクタ 149">
              <a:extLst>
                <a:ext uri="{FF2B5EF4-FFF2-40B4-BE49-F238E27FC236}">
                  <a16:creationId xmlns:a16="http://schemas.microsoft.com/office/drawing/2014/main" id="{D53A34D8-E79C-0449-9CD5-E7E775054E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5159" y="1663161"/>
              <a:ext cx="128032" cy="35567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id="{AFBB747E-8507-C645-BFF7-771D2D47287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86631" y="3008004"/>
              <a:ext cx="242815" cy="14682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矢印コネクタ 151">
              <a:extLst>
                <a:ext uri="{FF2B5EF4-FFF2-40B4-BE49-F238E27FC236}">
                  <a16:creationId xmlns:a16="http://schemas.microsoft.com/office/drawing/2014/main" id="{D9D37C9D-F65D-C341-8CBF-24169A0D65B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899283" y="2800441"/>
              <a:ext cx="34667" cy="10555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矢印コネクタ 152">
              <a:extLst>
                <a:ext uri="{FF2B5EF4-FFF2-40B4-BE49-F238E27FC236}">
                  <a16:creationId xmlns:a16="http://schemas.microsoft.com/office/drawing/2014/main" id="{040CAC7A-347B-8F46-83D7-31CEBF65982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43537" y="2005099"/>
              <a:ext cx="97698" cy="1507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0069332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54</TotalTime>
  <Words>216</Words>
  <Application>Microsoft Macintosh PowerPoint</Application>
  <PresentationFormat>画面に合わせる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9</cp:revision>
  <cp:lastPrinted>2020-08-18T02:49:06Z</cp:lastPrinted>
  <dcterms:created xsi:type="dcterms:W3CDTF">2017-02-28T00:50:21Z</dcterms:created>
  <dcterms:modified xsi:type="dcterms:W3CDTF">2020-11-20T14:38:34Z</dcterms:modified>
</cp:coreProperties>
</file>